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74"/>
  </p:normalViewPr>
  <p:slideViewPr>
    <p:cSldViewPr snapToGrid="0" snapToObjects="1">
      <p:cViewPr varScale="1">
        <p:scale>
          <a:sx n="131" d="100"/>
          <a:sy n="131" d="100"/>
        </p:scale>
        <p:origin x="37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684967-F733-B14D-83BE-9F36D76543B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7AD63AC-56F6-E045-96DC-34B39DFB80E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2B6065-5209-F442-96C4-9BB2D7ABAD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758C3-0F1A-564C-8C74-3E64648059C8}" type="datetimeFigureOut">
              <a:rPr lang="en-US" smtClean="0"/>
              <a:t>3/30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8310DF-910A-3A4A-B2F1-9409DA2CE4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22D63E-AE5E-1744-8D84-407799E371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AD61-E4CE-9C41-9DAA-257A6F22B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27293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0B4C62-3257-6B41-B18B-1B9E17611A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96023E-9483-A149-9885-4D179B6AE08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60DCDB-0633-2346-88D9-10150AB697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758C3-0F1A-564C-8C74-3E64648059C8}" type="datetimeFigureOut">
              <a:rPr lang="en-US" smtClean="0"/>
              <a:t>3/30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C57AAA-474D-BF4F-B9DD-C740209F3D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08521A-99F3-7749-824A-E70C02534E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AD61-E4CE-9C41-9DAA-257A6F22B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70508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560C5B0-8347-984F-A28D-A481729372D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F7175C0-91C5-1B47-AB91-71BE72833C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B945AD-CE9B-334E-8496-134BE746F7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758C3-0F1A-564C-8C74-3E64648059C8}" type="datetimeFigureOut">
              <a:rPr lang="en-US" smtClean="0"/>
              <a:t>3/30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C52089-0D6E-C642-B62F-9B01EA0E30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E56E3F-CE1F-CB49-83ED-C9E79AC95C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AD61-E4CE-9C41-9DAA-257A6F22B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2636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18BCB6-0C4D-814C-82FE-D5F1384EA5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E4DCDF-DBA5-044C-BD29-D274EF7C7AC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954D54-9784-C544-A4B4-CF12F36D7D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758C3-0F1A-564C-8C74-3E64648059C8}" type="datetimeFigureOut">
              <a:rPr lang="en-US" smtClean="0"/>
              <a:t>3/30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D68C82-5EEA-7C43-AAEE-088DB9ABD4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BC29DE-E233-BC4E-9C9C-9683BC2395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AD61-E4CE-9C41-9DAA-257A6F22B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7385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D478BD-9B06-2C43-85AC-09C4395E13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DC1C342-3850-4049-8CD2-E9999A83AB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AC5735-F8DC-9C4B-8CBB-2BD9B635EC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758C3-0F1A-564C-8C74-3E64648059C8}" type="datetimeFigureOut">
              <a:rPr lang="en-US" smtClean="0"/>
              <a:t>3/30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10FB5B-3C29-8045-9132-CD1871FBD1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AB3F49-EEDF-5544-9CFF-7058DAD613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AD61-E4CE-9C41-9DAA-257A6F22B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2602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774301-0B72-8341-A5DB-D441EB6CE5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25AD4C-2C51-C74E-A3BC-2F8192EF692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D7D24B3-B860-1343-99CB-892A172A0D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6A9279-FEE5-BE47-8D75-5513AAAD5B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758C3-0F1A-564C-8C74-3E64648059C8}" type="datetimeFigureOut">
              <a:rPr lang="en-US" smtClean="0"/>
              <a:t>3/30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B4BC69F-F0B4-904D-8094-238515486B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9DABBF0-BEAD-944A-A613-BE3B7FA8D2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AD61-E4CE-9C41-9DAA-257A6F22B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11559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E17E55-A883-DA43-9AA5-27A8CAD85A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5266359-2363-384E-862A-C77E25D16C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D8CFDE2-5A1E-7C44-ACE7-3E8F282C6F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8BD3741-6D38-E048-A763-93E54AA5649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829B4D1-7E51-C941-991A-55060952DBB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DB0D9CB-70E7-BF42-ABE3-7872859E10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758C3-0F1A-564C-8C74-3E64648059C8}" type="datetimeFigureOut">
              <a:rPr lang="en-US" smtClean="0"/>
              <a:t>3/30/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6755BC1-ED08-FB47-B562-52BE78E367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5D46770-1BB4-AB4F-84E2-92214E2EC8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AD61-E4CE-9C41-9DAA-257A6F22B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4902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84C0F0-2D83-8F4E-AE6F-61D4839BB1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C6A9F35-4B5D-0A41-A72F-FC16AFF30E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758C3-0F1A-564C-8C74-3E64648059C8}" type="datetimeFigureOut">
              <a:rPr lang="en-US" smtClean="0"/>
              <a:t>3/30/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569B2D2-AE54-F244-AE08-A73A3D5387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B518138-0A2D-0649-86B2-5D2708DA74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AD61-E4CE-9C41-9DAA-257A6F22B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51550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F01DB45-8566-4C41-8B98-B4E269A286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758C3-0F1A-564C-8C74-3E64648059C8}" type="datetimeFigureOut">
              <a:rPr lang="en-US" smtClean="0"/>
              <a:t>3/30/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7DF50A4-0DB1-7C4D-A033-CFD242D040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5622B83-7D57-134F-BEA6-D66F6FD746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AD61-E4CE-9C41-9DAA-257A6F22B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3115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341263-CA89-A64B-AD3D-A0BB766082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84E898-7431-D84B-9F21-14FC9988913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8F91EB5-93BF-D14D-81DF-EFF2AE6E69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381EF56-F465-DB41-90B1-E0C702B1E0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758C3-0F1A-564C-8C74-3E64648059C8}" type="datetimeFigureOut">
              <a:rPr lang="en-US" smtClean="0"/>
              <a:t>3/30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0AA827-475E-E94A-9717-3E5BFD1197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8E23B2-6AE0-A94A-A2BA-EE3D9A045A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AD61-E4CE-9C41-9DAA-257A6F22B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47177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3BE0A2-BEFA-8A46-BC29-63C5609998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5B7F25B-16E3-E442-B2B9-0656F75F17F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F7F349D-1AFB-B041-A67F-3E30EC32A7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6C1F3E7-A51A-D045-A7CA-D208479BF3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758C3-0F1A-564C-8C74-3E64648059C8}" type="datetimeFigureOut">
              <a:rPr lang="en-US" smtClean="0"/>
              <a:t>3/30/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F0A854A-1E84-CC46-AABF-B504195A20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A24EF2-F2C4-834E-981F-622DD4AE3D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F9AD61-E4CE-9C41-9DAA-257A6F22B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3870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CDB30F6-C957-DA4A-B20D-B97D7CFADC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689B11-E380-1C44-87B5-722B74979A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8F5FA3-5565-BA4F-B6B9-DF313BCD0BA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1758C3-0F1A-564C-8C74-3E64648059C8}" type="datetimeFigureOut">
              <a:rPr lang="en-US" smtClean="0"/>
              <a:t>3/30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5B17CC-5D75-614A-9AD4-9F9C4F14905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C6858B-74F5-714B-8CDF-0945E8F5D20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F9AD61-E4CE-9C41-9DAA-257A6F22B8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5273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20FAE454-DDBE-F84C-9700-8E27F009AFBE}"/>
              </a:ext>
            </a:extLst>
          </p:cNvPr>
          <p:cNvGrpSpPr/>
          <p:nvPr/>
        </p:nvGrpSpPr>
        <p:grpSpPr>
          <a:xfrm>
            <a:off x="1804498" y="146013"/>
            <a:ext cx="8407855" cy="6625084"/>
            <a:chOff x="1804498" y="146013"/>
            <a:chExt cx="8407855" cy="6625084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89F9F99-E52B-894A-8DB3-1F5A72601D8A}"/>
                </a:ext>
              </a:extLst>
            </p:cNvPr>
            <p:cNvSpPr txBox="1"/>
            <p:nvPr/>
          </p:nvSpPr>
          <p:spPr>
            <a:xfrm>
              <a:off x="2143390" y="5940100"/>
              <a:ext cx="8068963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3. Cumulative Visits to Each Zone By Strategy at Five Time Points.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ach strategy, over the course of the simulation visits multiple zones as it attempts to converge on hotspots of undiagnosed HIV infection. This is a representative set of grids for cumulative visits made to each zone by the three strategies at 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=5, 45, 90, 135 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0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n a setting of </a:t>
              </a:r>
              <a:r>
                <a:rPr lang="en-US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>medium correlation in the data.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D6C0FB12-8E06-7740-AE4E-32068605A05C}"/>
                </a:ext>
              </a:extLst>
            </p:cNvPr>
            <p:cNvGrpSpPr/>
            <p:nvPr/>
          </p:nvGrpSpPr>
          <p:grpSpPr>
            <a:xfrm>
              <a:off x="1804498" y="146013"/>
              <a:ext cx="7416923" cy="4740924"/>
              <a:chOff x="1804498" y="146013"/>
              <a:chExt cx="7416923" cy="4740924"/>
            </a:xfrm>
          </p:grpSpPr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6F5E4827-3F4A-4943-9252-391EADE9B399}"/>
                  </a:ext>
                </a:extLst>
              </p:cNvPr>
              <p:cNvSpPr txBox="1"/>
              <p:nvPr/>
            </p:nvSpPr>
            <p:spPr>
              <a:xfrm>
                <a:off x="5938864" y="146013"/>
                <a:ext cx="47801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=90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22985FAB-FD30-F447-A7FD-D6804F9D362F}"/>
                  </a:ext>
                </a:extLst>
              </p:cNvPr>
              <p:cNvSpPr txBox="1"/>
              <p:nvPr/>
            </p:nvSpPr>
            <p:spPr>
              <a:xfrm>
                <a:off x="4613538" y="146013"/>
                <a:ext cx="47801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=45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2474E02C-DAA9-EA45-A387-BCD905D38ECB}"/>
                  </a:ext>
                </a:extLst>
              </p:cNvPr>
              <p:cNvSpPr txBox="1"/>
              <p:nvPr/>
            </p:nvSpPr>
            <p:spPr>
              <a:xfrm>
                <a:off x="3365156" y="146013"/>
                <a:ext cx="40107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=5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D2161D5E-8E67-2C4E-A252-7E066F74A2D7}"/>
                  </a:ext>
                </a:extLst>
              </p:cNvPr>
              <p:cNvSpPr txBox="1"/>
              <p:nvPr/>
            </p:nvSpPr>
            <p:spPr>
              <a:xfrm>
                <a:off x="7264190" y="146013"/>
                <a:ext cx="5549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=135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97F79E66-AC86-8447-84B0-6E024D2422E5}"/>
                  </a:ext>
                </a:extLst>
              </p:cNvPr>
              <p:cNvSpPr txBox="1"/>
              <p:nvPr/>
            </p:nvSpPr>
            <p:spPr>
              <a:xfrm>
                <a:off x="8666461" y="146013"/>
                <a:ext cx="55496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=180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312D14EC-5DAF-4B4C-828D-9AC2ECB5B58D}"/>
                  </a:ext>
                </a:extLst>
              </p:cNvPr>
              <p:cNvSpPr txBox="1"/>
              <p:nvPr/>
            </p:nvSpPr>
            <p:spPr>
              <a:xfrm>
                <a:off x="1883993" y="964039"/>
                <a:ext cx="91440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hompson Sampling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E7CE39AA-A296-8447-8D7C-8904DD8DA4FF}"/>
                  </a:ext>
                </a:extLst>
              </p:cNvPr>
              <p:cNvSpPr txBox="1"/>
              <p:nvPr/>
            </p:nvSpPr>
            <p:spPr>
              <a:xfrm>
                <a:off x="1883993" y="2879321"/>
                <a:ext cx="9144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YM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FD23FADC-E568-3144-894C-7E89C8F36806}"/>
                  </a:ext>
                </a:extLst>
              </p:cNvPr>
              <p:cNvSpPr txBox="1"/>
              <p:nvPr/>
            </p:nvSpPr>
            <p:spPr>
              <a:xfrm>
                <a:off x="1804498" y="4609938"/>
                <a:ext cx="10733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lairvoyance</a:t>
                </a:r>
              </a:p>
            </p:txBody>
          </p:sp>
        </p:grpSp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0FC56D91-829D-F440-B50E-51F6B20836C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10345"/>
            <a:stretch/>
          </p:blipFill>
          <p:spPr>
            <a:xfrm>
              <a:off x="2907569" y="4266748"/>
              <a:ext cx="6636220" cy="1673352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88C7D5FE-1F96-EE42-A15C-EB66085922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11140"/>
            <a:stretch/>
          </p:blipFill>
          <p:spPr>
            <a:xfrm>
              <a:off x="2877888" y="2449561"/>
              <a:ext cx="6695582" cy="1673352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635683D3-95BF-8649-8801-C4A74C4B619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10731"/>
            <a:stretch/>
          </p:blipFill>
          <p:spPr>
            <a:xfrm>
              <a:off x="2877888" y="509237"/>
              <a:ext cx="6664933" cy="167335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78194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98</Words>
  <Application>Microsoft Macintosh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nsalves, Gregg</dc:creator>
  <cp:lastModifiedBy>Gonsalves, Gregg</cp:lastModifiedBy>
  <cp:revision>3</cp:revision>
  <dcterms:created xsi:type="dcterms:W3CDTF">2018-03-29T12:15:24Z</dcterms:created>
  <dcterms:modified xsi:type="dcterms:W3CDTF">2018-03-30T10:41:20Z</dcterms:modified>
</cp:coreProperties>
</file>